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jpeg" ContentType="image/jpeg"/>
  <Override PartName="/ppt/media/image3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8456F9-0F55-466C-B2B4-E033C822C4E6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0F02BC-A608-4642-BB6D-E5E1BA748866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508B5-AC12-416C-9CEA-6E93B17C8B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456C0D-F45C-43AC-8951-B3C8D66C59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3AFB5-DFBC-4D32-BBB7-0EDB4AE9CA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EBF87-1E46-4BE2-A370-CF104923DE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D4F69-D260-43A0-B857-1A14FD0CF1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64396-B9B6-4183-906C-301BA3C340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0D17D-3B2F-41BF-9182-B31CDCE673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03AF38-70E8-4592-8BB6-8F00CEE896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61258-2F39-46F9-B52B-C1BC7C9264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D3B35-5B5C-4A16-9BB4-1664B87B6B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E8B1C-9326-44BB-878C-E20E13021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F6775-1AC8-4B33-B6E0-B972919EA0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65BEB9-3E32-47F6-B77D-52E63DEE0F89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0"/>
          <p:cNvGrpSpPr/>
          <p:nvPr/>
        </p:nvGrpSpPr>
        <p:grpSpPr>
          <a:xfrm>
            <a:off x="255600" y="372960"/>
            <a:ext cx="6348240" cy="7183080"/>
            <a:chOff x="255600" y="372960"/>
            <a:chExt cx="6348240" cy="7183080"/>
          </a:xfrm>
        </p:grpSpPr>
        <p:sp>
          <p:nvSpPr>
            <p:cNvPr id="49" name="TextBox 19"/>
            <p:cNvSpPr/>
            <p:nvPr/>
          </p:nvSpPr>
          <p:spPr>
            <a:xfrm>
              <a:off x="255600" y="372960"/>
              <a:ext cx="718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S3 Fig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0" name="Group 3"/>
            <p:cNvGrpSpPr/>
            <p:nvPr/>
          </p:nvGrpSpPr>
          <p:grpSpPr>
            <a:xfrm>
              <a:off x="721440" y="1153800"/>
              <a:ext cx="5532840" cy="6093000"/>
              <a:chOff x="721440" y="1153800"/>
              <a:chExt cx="5532840" cy="6093000"/>
            </a:xfrm>
          </p:grpSpPr>
          <p:sp>
            <p:nvSpPr>
              <p:cNvPr id="51" name="TextBox 7"/>
              <p:cNvSpPr/>
              <p:nvPr/>
            </p:nvSpPr>
            <p:spPr>
              <a:xfrm rot="16200000">
                <a:off x="301680" y="2670480"/>
                <a:ext cx="1477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Calibri"/>
                  </a:rPr>
                  <a:t>AKIP1:GAPDH mRN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8"/>
              <p:cNvSpPr/>
              <p:nvPr/>
            </p:nvSpPr>
            <p:spPr>
              <a:xfrm rot="16200000">
                <a:off x="3059640" y="2734200"/>
                <a:ext cx="1430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Calibri"/>
                  </a:rPr>
                  <a:t>AKIP1:GAPDH protei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9"/>
              <p:cNvSpPr/>
              <p:nvPr/>
            </p:nvSpPr>
            <p:spPr>
              <a:xfrm rot="16200000">
                <a:off x="3059640" y="6341400"/>
                <a:ext cx="1430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Calibri"/>
                  </a:rPr>
                  <a:t>COX-2GAPDH protei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0"/>
              <p:cNvSpPr/>
              <p:nvPr/>
            </p:nvSpPr>
            <p:spPr>
              <a:xfrm rot="16200000">
                <a:off x="250920" y="6375240"/>
                <a:ext cx="1496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Calibri"/>
                  </a:rPr>
                  <a:t>COX-2:GAPDH mRN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TextBox 11"/>
              <p:cNvSpPr/>
              <p:nvPr/>
            </p:nvSpPr>
            <p:spPr>
              <a:xfrm>
                <a:off x="721440" y="1153800"/>
                <a:ext cx="289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Calibri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12"/>
              <p:cNvSpPr/>
              <p:nvPr/>
            </p:nvSpPr>
            <p:spPr>
              <a:xfrm>
                <a:off x="3350880" y="1153800"/>
                <a:ext cx="2811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13"/>
              <p:cNvSpPr/>
              <p:nvPr/>
            </p:nvSpPr>
            <p:spPr>
              <a:xfrm>
                <a:off x="721440" y="4640040"/>
                <a:ext cx="2750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14"/>
              <p:cNvSpPr/>
              <p:nvPr/>
            </p:nvSpPr>
            <p:spPr>
              <a:xfrm>
                <a:off x="3327480" y="4640040"/>
                <a:ext cx="293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Calibri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59" name="Picture 19" descr=""/>
              <p:cNvPicPr/>
              <p:nvPr/>
            </p:nvPicPr>
            <p:blipFill>
              <a:blip r:embed="rId1"/>
              <a:stretch/>
            </p:blipFill>
            <p:spPr>
              <a:xfrm>
                <a:off x="3778920" y="1269360"/>
                <a:ext cx="2470680" cy="731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0" name="Picture 20" descr=""/>
              <p:cNvPicPr/>
              <p:nvPr/>
            </p:nvPicPr>
            <p:blipFill>
              <a:blip r:embed="rId2"/>
              <a:stretch/>
            </p:blipFill>
            <p:spPr>
              <a:xfrm>
                <a:off x="3799440" y="4854240"/>
                <a:ext cx="2454840" cy="731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TextBox 18"/>
              <p:cNvSpPr/>
              <p:nvPr/>
            </p:nvSpPr>
            <p:spPr>
              <a:xfrm>
                <a:off x="4515480" y="3533760"/>
                <a:ext cx="1610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PTNL        TNL             T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2" name="Group 8"/>
            <p:cNvGrpSpPr/>
            <p:nvPr/>
          </p:nvGrpSpPr>
          <p:grpSpPr>
            <a:xfrm>
              <a:off x="1226880" y="1402560"/>
              <a:ext cx="2382840" cy="2455200"/>
              <a:chOff x="1226880" y="1402560"/>
              <a:chExt cx="2382840" cy="2455200"/>
            </a:xfrm>
          </p:grpSpPr>
          <p:sp>
            <p:nvSpPr>
              <p:cNvPr id="63" name="TextBox 18"/>
              <p:cNvSpPr/>
              <p:nvPr/>
            </p:nvSpPr>
            <p:spPr>
              <a:xfrm>
                <a:off x="1621440" y="3581280"/>
                <a:ext cx="1610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PTNL        TNL             T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4" name="Picture 3" descr=""/>
              <p:cNvPicPr/>
              <p:nvPr/>
            </p:nvPicPr>
            <p:blipFill>
              <a:blip r:embed="rId3"/>
              <a:srcRect l="10866" t="0" r="0" b="33899"/>
              <a:stretch/>
            </p:blipFill>
            <p:spPr>
              <a:xfrm>
                <a:off x="1226880" y="1402560"/>
                <a:ext cx="2382840" cy="22320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65" name="Group 7"/>
            <p:cNvGrpSpPr/>
            <p:nvPr/>
          </p:nvGrpSpPr>
          <p:grpSpPr>
            <a:xfrm>
              <a:off x="939240" y="5540040"/>
              <a:ext cx="5664600" cy="2016000"/>
              <a:chOff x="939240" y="5540040"/>
              <a:chExt cx="5664600" cy="2016000"/>
            </a:xfrm>
          </p:grpSpPr>
          <p:pic>
            <p:nvPicPr>
              <p:cNvPr id="66" name="Picture 5" descr=""/>
              <p:cNvPicPr/>
              <p:nvPr/>
            </p:nvPicPr>
            <p:blipFill>
              <a:blip r:embed="rId4"/>
              <a:srcRect l="0" t="9524" r="0" b="35661"/>
              <a:stretch/>
            </p:blipFill>
            <p:spPr>
              <a:xfrm>
                <a:off x="939240" y="5644440"/>
                <a:ext cx="2796480" cy="162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TextBox 18"/>
              <p:cNvSpPr/>
              <p:nvPr/>
            </p:nvSpPr>
            <p:spPr>
              <a:xfrm>
                <a:off x="4551120" y="7279560"/>
                <a:ext cx="1680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PTNL          TNL             T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18"/>
              <p:cNvSpPr/>
              <p:nvPr/>
            </p:nvSpPr>
            <p:spPr>
              <a:xfrm>
                <a:off x="1628640" y="7246800"/>
                <a:ext cx="1800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PTNL            TNL              T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9" name="Picture 6" descr=""/>
              <p:cNvPicPr/>
              <p:nvPr/>
            </p:nvPicPr>
            <p:blipFill>
              <a:blip r:embed="rId5"/>
              <a:srcRect l="8877" t="0" r="0" b="36908"/>
              <a:stretch/>
            </p:blipFill>
            <p:spPr>
              <a:xfrm>
                <a:off x="4061520" y="5540040"/>
                <a:ext cx="2542320" cy="176436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70" name="Picture 9" descr=""/>
            <p:cNvPicPr/>
            <p:nvPr/>
          </p:nvPicPr>
          <p:blipFill>
            <a:blip r:embed="rId6"/>
            <a:srcRect l="8474" t="0" r="0" b="42618"/>
            <a:stretch/>
          </p:blipFill>
          <p:spPr>
            <a:xfrm>
              <a:off x="3823560" y="1773000"/>
              <a:ext cx="2760480" cy="180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9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07T11:19:21Z</dcterms:created>
  <dc:creator>Angela</dc:creator>
  <dc:description/>
  <dc:language>en-US</dc:language>
  <cp:lastModifiedBy>chn off28</cp:lastModifiedBy>
  <dcterms:modified xsi:type="dcterms:W3CDTF">2021-06-16T07:57:55Z</dcterms:modified>
  <cp:revision>346</cp:revision>
  <dc:subject/>
  <dc:title>PowerPoint Presentation</dc:title>
</cp:coreProperties>
</file>